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png" ContentType="image/png"/>
  <Override PartName="/ppt/media/image5.jpeg" ContentType="image/jpe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ko-K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AE6D43-A8D0-4814-8044-68C0BC36CFA8}" type="datetime">
              <a:rPr b="1" lang="ko-KR" sz="1200" spc="-1" strike="noStrike">
                <a:solidFill>
                  <a:srgbClr val="000000"/>
                </a:solidFill>
                <a:latin typeface="Arial"/>
              </a:rPr>
              <a:t>26年 8月 29日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3400" y="744120"/>
            <a:ext cx="279072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ko-K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437655-27A2-4325-97A2-4309BAC91C00}" type="slidenum">
              <a:rPr b="1" lang="ko-K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맑은 고딕"/>
              <a:ea typeface="맑은 고딕"/>
            </a:endParaRPr>
          </a:p>
        </p:txBody>
      </p:sp>
      <p:sp>
        <p:nvSpPr>
          <p:cNvPr id="125" name="슬라이드 번호 개체 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0ADB5B-31C6-4889-96F1-76BB90F7DA8E}" type="slidenum">
              <a:rPr b="1" lang="ko-K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8208A8-61EE-45CD-93B9-4DBBBE3786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9A3E0E-EA81-4704-9ED7-92F77209FD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1EB688-C775-4724-AADE-BB9B7A155A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75159E-3FDC-4A37-8CB4-E0C3DF1052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D35DFD-44F0-417F-B0AA-23C42ED85F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67391-3425-42E4-84F7-D80EBCE122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899581-798B-4291-A9F0-F4972140B8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207B6-0209-42BA-AD37-60FFBE99E4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9769F9-C7F7-4A22-AF5C-BC5B744F7A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38AD3-4CF2-456E-A1C5-FB87A3AF04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6BB75-D12D-4F4C-B669-F761F3333D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564771-4EA8-4929-B227-385B9550D9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5E3BE3-9A47-4F39-BBBC-82223F5A52E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1.jpeg"/><Relationship Id="rId8" Type="http://schemas.openxmlformats.org/officeDocument/2006/relationships/image" Target="../media/image2.jpeg"/><Relationship Id="rId9" Type="http://schemas.openxmlformats.org/officeDocument/2006/relationships/image" Target="../media/image3.jpeg"/><Relationship Id="rId10" Type="http://schemas.openxmlformats.org/officeDocument/2006/relationships/image" Target="../media/image4.png"/><Relationship Id="rId11" Type="http://schemas.openxmlformats.org/officeDocument/2006/relationships/image" Target="../media/image5.jpeg"/><Relationship Id="rId12" Type="http://schemas.openxmlformats.org/officeDocument/2006/relationships/image" Target="../media/image6.png"/><Relationship Id="rId13" Type="http://schemas.openxmlformats.org/officeDocument/2006/relationships/image" Target="../media/image1.jpeg"/><Relationship Id="rId14" Type="http://schemas.openxmlformats.org/officeDocument/2006/relationships/image" Target="../media/image2.jpeg"/><Relationship Id="rId15" Type="http://schemas.openxmlformats.org/officeDocument/2006/relationships/image" Target="../media/image3.jpeg"/><Relationship Id="rId16" Type="http://schemas.openxmlformats.org/officeDocument/2006/relationships/image" Target="../media/image4.png"/><Relationship Id="rId17" Type="http://schemas.openxmlformats.org/officeDocument/2006/relationships/image" Target="../media/image5.jpeg"/><Relationship Id="rId18" Type="http://schemas.openxmlformats.org/officeDocument/2006/relationships/image" Target="../media/image6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그룹 12"/>
          <p:cNvGrpSpPr/>
          <p:nvPr/>
        </p:nvGrpSpPr>
        <p:grpSpPr>
          <a:xfrm>
            <a:off x="1701720" y="2252520"/>
            <a:ext cx="1152720" cy="895320"/>
            <a:chOff x="1701720" y="2252520"/>
            <a:chExt cx="1152720" cy="895320"/>
          </a:xfrm>
        </p:grpSpPr>
        <p:pic>
          <p:nvPicPr>
            <p:cNvPr id="49" name="Picture 1" descr="F:\HRK1\for ppt\H99.jpg"/>
            <p:cNvPicPr/>
            <p:nvPr/>
          </p:nvPicPr>
          <p:blipFill>
            <a:blip r:embed="rId1"/>
            <a:srcRect l="1861" t="22638" r="65708" b="11549"/>
            <a:stretch/>
          </p:blipFill>
          <p:spPr>
            <a:xfrm>
              <a:off x="1701720" y="2716560"/>
              <a:ext cx="1152720" cy="431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0" name="Picture 54" descr="G:\서영 삼성 랩탑\HRK1\northern\2weeks\H99.jpg"/>
            <p:cNvPicPr/>
            <p:nvPr/>
          </p:nvPicPr>
          <p:blipFill>
            <a:blip r:embed="rId2">
              <a:grayscl/>
              <a:lum contrast="34000"/>
            </a:blip>
            <a:srcRect l="0" t="0" r="65711" b="-12940"/>
            <a:stretch/>
          </p:blipFill>
          <p:spPr>
            <a:xfrm>
              <a:off x="1701720" y="2252520"/>
              <a:ext cx="1152720" cy="431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grpSp>
        <p:nvGrpSpPr>
          <p:cNvPr id="51" name="그룹 11"/>
          <p:cNvGrpSpPr/>
          <p:nvPr/>
        </p:nvGrpSpPr>
        <p:grpSpPr>
          <a:xfrm>
            <a:off x="2946240" y="2247840"/>
            <a:ext cx="1152720" cy="895320"/>
            <a:chOff x="2946240" y="2247840"/>
            <a:chExt cx="1152720" cy="895320"/>
          </a:xfrm>
        </p:grpSpPr>
        <p:pic>
          <p:nvPicPr>
            <p:cNvPr id="52" name="Picture 1" descr="F:\HRK1\for ppt\hog1.jpg"/>
            <p:cNvPicPr/>
            <p:nvPr/>
          </p:nvPicPr>
          <p:blipFill>
            <a:blip r:embed="rId3"/>
            <a:srcRect l="1935" t="20061" r="65658" b="18774"/>
            <a:stretch/>
          </p:blipFill>
          <p:spPr>
            <a:xfrm>
              <a:off x="2946240" y="2711160"/>
              <a:ext cx="1152720" cy="43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3" name="Picture 54" descr="G:\서영 삼성 랩탑\HRK1\northern\2weeks\hog1.jpg"/>
            <p:cNvPicPr/>
            <p:nvPr/>
          </p:nvPicPr>
          <p:blipFill>
            <a:blip r:embed="rId4"/>
            <a:srcRect l="0" t="0" r="65717" b="2487"/>
            <a:stretch/>
          </p:blipFill>
          <p:spPr>
            <a:xfrm>
              <a:off x="2946240" y="2247840"/>
              <a:ext cx="1152720" cy="43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grpSp>
        <p:nvGrpSpPr>
          <p:cNvPr id="54" name="그룹 10"/>
          <p:cNvGrpSpPr/>
          <p:nvPr/>
        </p:nvGrpSpPr>
        <p:grpSpPr>
          <a:xfrm>
            <a:off x="4191120" y="2251080"/>
            <a:ext cx="1152360" cy="892080"/>
            <a:chOff x="4191120" y="2251080"/>
            <a:chExt cx="1152360" cy="892080"/>
          </a:xfrm>
        </p:grpSpPr>
        <p:pic>
          <p:nvPicPr>
            <p:cNvPr id="55" name="Picture 1" descr="F:\HRK1\for ppt\ssk1.jpg"/>
            <p:cNvPicPr/>
            <p:nvPr/>
          </p:nvPicPr>
          <p:blipFill>
            <a:blip r:embed="rId5"/>
            <a:srcRect l="3645" t="13506" r="65983" b="13432"/>
            <a:stretch/>
          </p:blipFill>
          <p:spPr>
            <a:xfrm>
              <a:off x="4191120" y="2719800"/>
              <a:ext cx="1152360" cy="423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6" name="Picture 54" descr="G:\서영 삼성 랩탑\HRK1\northern\2weeks\ssk1.jpg"/>
            <p:cNvPicPr/>
            <p:nvPr/>
          </p:nvPicPr>
          <p:blipFill>
            <a:blip r:embed="rId6"/>
            <a:srcRect l="0" t="0" r="65701" b="8859"/>
            <a:stretch/>
          </p:blipFill>
          <p:spPr>
            <a:xfrm>
              <a:off x="4191120" y="2251080"/>
              <a:ext cx="1152360" cy="431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sp>
        <p:nvSpPr>
          <p:cNvPr id="57" name="TextBox 78"/>
          <p:cNvSpPr/>
          <p:nvPr/>
        </p:nvSpPr>
        <p:spPr>
          <a:xfrm rot="16200000">
            <a:off x="1211760" y="2543400"/>
            <a:ext cx="57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aC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79"/>
          <p:cNvSpPr/>
          <p:nvPr/>
        </p:nvSpPr>
        <p:spPr>
          <a:xfrm rot="16200000">
            <a:off x="1232280" y="3826080"/>
            <a:ext cx="56340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80"/>
          <p:cNvSpPr/>
          <p:nvPr/>
        </p:nvSpPr>
        <p:spPr>
          <a:xfrm rot="16200000">
            <a:off x="1002240" y="5282640"/>
            <a:ext cx="1032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ludioxoni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직선 연결선 44"/>
          <p:cNvSpPr/>
          <p:nvPr/>
        </p:nvSpPr>
        <p:spPr>
          <a:xfrm flipV="1">
            <a:off x="1646280" y="2260440"/>
            <a:ext cx="0" cy="912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직선 연결선 44"/>
          <p:cNvSpPr/>
          <p:nvPr/>
        </p:nvSpPr>
        <p:spPr>
          <a:xfrm flipV="1">
            <a:off x="1646280" y="3587760"/>
            <a:ext cx="0" cy="912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" name="그룹 9"/>
          <p:cNvGrpSpPr/>
          <p:nvPr/>
        </p:nvGrpSpPr>
        <p:grpSpPr>
          <a:xfrm>
            <a:off x="1643040" y="1790640"/>
            <a:ext cx="4349880" cy="1257840"/>
            <a:chOff x="1643040" y="1790640"/>
            <a:chExt cx="4349880" cy="1257840"/>
          </a:xfrm>
        </p:grpSpPr>
        <p:sp>
          <p:nvSpPr>
            <p:cNvPr id="63" name="직선 연결선 44"/>
            <p:cNvSpPr/>
            <p:nvPr/>
          </p:nvSpPr>
          <p:spPr>
            <a:xfrm flipH="1" flipV="1">
              <a:off x="1744560" y="2030400"/>
              <a:ext cx="1079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45"/>
            <p:cNvSpPr/>
            <p:nvPr/>
          </p:nvSpPr>
          <p:spPr>
            <a:xfrm>
              <a:off x="1643040" y="1790640"/>
              <a:ext cx="1347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WT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75"/>
            <p:cNvSpPr/>
            <p:nvPr/>
          </p:nvSpPr>
          <p:spPr>
            <a:xfrm>
              <a:off x="1803240" y="2000520"/>
              <a:ext cx="1042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     30    60   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76"/>
            <p:cNvSpPr/>
            <p:nvPr/>
          </p:nvSpPr>
          <p:spPr>
            <a:xfrm>
              <a:off x="3053160" y="2000520"/>
              <a:ext cx="1119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     30    60   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77"/>
            <p:cNvSpPr/>
            <p:nvPr/>
          </p:nvSpPr>
          <p:spPr>
            <a:xfrm>
              <a:off x="4324320" y="2000520"/>
              <a:ext cx="1492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     30    60   min   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87"/>
            <p:cNvSpPr/>
            <p:nvPr/>
          </p:nvSpPr>
          <p:spPr>
            <a:xfrm>
              <a:off x="5305680" y="238032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RK1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88"/>
            <p:cNvSpPr/>
            <p:nvPr/>
          </p:nvSpPr>
          <p:spPr>
            <a:xfrm>
              <a:off x="5307120" y="280224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RNA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45"/>
            <p:cNvSpPr/>
            <p:nvPr/>
          </p:nvSpPr>
          <p:spPr>
            <a:xfrm>
              <a:off x="3031920" y="1795320"/>
              <a:ext cx="99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og1</a:t>
              </a:r>
              <a:r>
                <a:rPr b="0" i="1" lang="el-G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45"/>
            <p:cNvSpPr/>
            <p:nvPr/>
          </p:nvSpPr>
          <p:spPr>
            <a:xfrm>
              <a:off x="4307400" y="1795320"/>
              <a:ext cx="99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sk1</a:t>
              </a:r>
              <a:r>
                <a:rPr b="0" i="1" lang="el-G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직선 연결선 44"/>
          <p:cNvSpPr/>
          <p:nvPr/>
        </p:nvSpPr>
        <p:spPr>
          <a:xfrm flipV="1">
            <a:off x="1650960" y="5000400"/>
            <a:ext cx="0" cy="912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3" name="그룹 8"/>
          <p:cNvGrpSpPr/>
          <p:nvPr/>
        </p:nvGrpSpPr>
        <p:grpSpPr>
          <a:xfrm>
            <a:off x="1695600" y="5003640"/>
            <a:ext cx="1152360" cy="895680"/>
            <a:chOff x="1695600" y="5003640"/>
            <a:chExt cx="1152360" cy="895680"/>
          </a:xfrm>
        </p:grpSpPr>
        <p:pic>
          <p:nvPicPr>
            <p:cNvPr id="74" name="Picture 1" descr="F:\HRK1\for ppt\H99.jpg"/>
            <p:cNvPicPr/>
            <p:nvPr/>
          </p:nvPicPr>
          <p:blipFill>
            <a:blip r:embed="rId7"/>
            <a:srcRect l="64935" t="22638" r="3538" b="12861"/>
            <a:stretch/>
          </p:blipFill>
          <p:spPr>
            <a:xfrm>
              <a:off x="1695600" y="5467680"/>
              <a:ext cx="1152360" cy="431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5" name="Picture 54" descr="G:\서영 삼성 랩탑\HRK1\northern\2weeks\H99.jpg"/>
            <p:cNvPicPr/>
            <p:nvPr/>
          </p:nvPicPr>
          <p:blipFill>
            <a:blip r:embed="rId8">
              <a:grayscl/>
              <a:lum contrast="34000"/>
            </a:blip>
            <a:srcRect l="66685" t="0" r="0" b="-10549"/>
            <a:stretch/>
          </p:blipFill>
          <p:spPr>
            <a:xfrm>
              <a:off x="1695600" y="5003640"/>
              <a:ext cx="1152360" cy="431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grpSp>
        <p:nvGrpSpPr>
          <p:cNvPr id="76" name="그룹 7"/>
          <p:cNvGrpSpPr/>
          <p:nvPr/>
        </p:nvGrpSpPr>
        <p:grpSpPr>
          <a:xfrm>
            <a:off x="2930400" y="5003640"/>
            <a:ext cx="1152720" cy="895680"/>
            <a:chOff x="2930400" y="5003640"/>
            <a:chExt cx="1152720" cy="895680"/>
          </a:xfrm>
        </p:grpSpPr>
        <p:pic>
          <p:nvPicPr>
            <p:cNvPr id="77" name="Picture 1" descr="F:\HRK1\for ppt\hog1.jpg"/>
            <p:cNvPicPr/>
            <p:nvPr/>
          </p:nvPicPr>
          <p:blipFill>
            <a:blip r:embed="rId9"/>
            <a:srcRect l="64947" t="20061" r="3559" b="19985"/>
            <a:stretch/>
          </p:blipFill>
          <p:spPr>
            <a:xfrm>
              <a:off x="2930400" y="5467320"/>
              <a:ext cx="1152720" cy="43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8" name="Picture 54" descr="G:\서영 삼성 랩탑\HRK1\northern\2weeks\hog1.jpg"/>
            <p:cNvPicPr/>
            <p:nvPr/>
          </p:nvPicPr>
          <p:blipFill>
            <a:blip r:embed="rId10"/>
            <a:srcRect l="66686" t="0" r="0" b="4974"/>
            <a:stretch/>
          </p:blipFill>
          <p:spPr>
            <a:xfrm>
              <a:off x="2930400" y="5003640"/>
              <a:ext cx="1152720" cy="43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grpSp>
        <p:nvGrpSpPr>
          <p:cNvPr id="79" name="그룹 6"/>
          <p:cNvGrpSpPr/>
          <p:nvPr/>
        </p:nvGrpSpPr>
        <p:grpSpPr>
          <a:xfrm>
            <a:off x="4175280" y="5006880"/>
            <a:ext cx="1152360" cy="887400"/>
            <a:chOff x="4175280" y="5006880"/>
            <a:chExt cx="1152360" cy="887400"/>
          </a:xfrm>
        </p:grpSpPr>
        <p:pic>
          <p:nvPicPr>
            <p:cNvPr id="80" name="Picture 1" descr="F:\HRK1\for ppt\ssk1.jpg"/>
            <p:cNvPicPr/>
            <p:nvPr/>
          </p:nvPicPr>
          <p:blipFill>
            <a:blip r:embed="rId11"/>
            <a:srcRect l="65604" t="13506" r="3426" b="22657"/>
            <a:stretch/>
          </p:blipFill>
          <p:spPr>
            <a:xfrm>
              <a:off x="4175280" y="5468760"/>
              <a:ext cx="1152360" cy="4255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1" name="Picture 54" descr="G:\서영 삼성 랩탑\HRK1\northern\2weeks\ssk1.jpg"/>
            <p:cNvPicPr/>
            <p:nvPr/>
          </p:nvPicPr>
          <p:blipFill>
            <a:blip r:embed="rId12"/>
            <a:srcRect l="64603" t="0" r="4164" b="11141"/>
            <a:stretch/>
          </p:blipFill>
          <p:spPr>
            <a:xfrm>
              <a:off x="4175280" y="5006880"/>
              <a:ext cx="1152360" cy="4240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grpSp>
        <p:nvGrpSpPr>
          <p:cNvPr id="82" name="그룹 5"/>
          <p:cNvGrpSpPr/>
          <p:nvPr/>
        </p:nvGrpSpPr>
        <p:grpSpPr>
          <a:xfrm>
            <a:off x="1692360" y="3594240"/>
            <a:ext cx="1152360" cy="895320"/>
            <a:chOff x="1692360" y="3594240"/>
            <a:chExt cx="1152360" cy="895320"/>
          </a:xfrm>
        </p:grpSpPr>
        <p:pic>
          <p:nvPicPr>
            <p:cNvPr id="83" name="Picture 1" descr="F:\HRK1\for ppt\H99.jpg"/>
            <p:cNvPicPr/>
            <p:nvPr/>
          </p:nvPicPr>
          <p:blipFill>
            <a:blip r:embed="rId13"/>
            <a:srcRect l="33389" t="22638" r="35084" b="12861"/>
            <a:stretch/>
          </p:blipFill>
          <p:spPr>
            <a:xfrm>
              <a:off x="1692360" y="4058280"/>
              <a:ext cx="1152360" cy="431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4" name="Picture 54" descr="G:\서영 삼성 랩탑\HRK1\northern\2weeks\H99.jpg"/>
            <p:cNvPicPr/>
            <p:nvPr/>
          </p:nvPicPr>
          <p:blipFill>
            <a:blip r:embed="rId14">
              <a:grayscl/>
              <a:lum contrast="34000"/>
            </a:blip>
            <a:srcRect l="33333" t="0" r="33333" b="7736"/>
            <a:stretch/>
          </p:blipFill>
          <p:spPr>
            <a:xfrm>
              <a:off x="1692360" y="3594240"/>
              <a:ext cx="1152360" cy="431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grpSp>
        <p:nvGrpSpPr>
          <p:cNvPr id="85" name="그룹 4"/>
          <p:cNvGrpSpPr/>
          <p:nvPr/>
        </p:nvGrpSpPr>
        <p:grpSpPr>
          <a:xfrm>
            <a:off x="2936880" y="3591000"/>
            <a:ext cx="1152360" cy="900000"/>
            <a:chOff x="2936880" y="3591000"/>
            <a:chExt cx="1152360" cy="900000"/>
          </a:xfrm>
        </p:grpSpPr>
        <p:pic>
          <p:nvPicPr>
            <p:cNvPr id="86" name="Picture 1" descr="F:\HRK1\for ppt\hog1.jpg"/>
            <p:cNvPicPr/>
            <p:nvPr/>
          </p:nvPicPr>
          <p:blipFill>
            <a:blip r:embed="rId15"/>
            <a:srcRect l="34364" t="20061" r="34030" b="19985"/>
            <a:stretch/>
          </p:blipFill>
          <p:spPr>
            <a:xfrm>
              <a:off x="2936880" y="4059720"/>
              <a:ext cx="1152360" cy="431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7" name="Picture 54" descr="G:\서영 삼성 랩탑\HRK1\northern\2weeks\hog1.jpg"/>
            <p:cNvPicPr/>
            <p:nvPr/>
          </p:nvPicPr>
          <p:blipFill>
            <a:blip r:embed="rId16"/>
            <a:srcRect l="33333" t="0" r="33333" b="-13679"/>
            <a:stretch/>
          </p:blipFill>
          <p:spPr>
            <a:xfrm>
              <a:off x="2936880" y="3591000"/>
              <a:ext cx="1152360" cy="431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grpSp>
        <p:nvGrpSpPr>
          <p:cNvPr id="88" name="그룹 3"/>
          <p:cNvGrpSpPr/>
          <p:nvPr/>
        </p:nvGrpSpPr>
        <p:grpSpPr>
          <a:xfrm>
            <a:off x="4191120" y="3591000"/>
            <a:ext cx="1152360" cy="901800"/>
            <a:chOff x="4191120" y="3591000"/>
            <a:chExt cx="1152360" cy="901800"/>
          </a:xfrm>
        </p:grpSpPr>
        <p:pic>
          <p:nvPicPr>
            <p:cNvPr id="89" name="Picture 1" descr="F:\HRK1\for ppt\ssk1.jpg"/>
            <p:cNvPicPr/>
            <p:nvPr/>
          </p:nvPicPr>
          <p:blipFill>
            <a:blip r:embed="rId17"/>
            <a:srcRect l="34635" t="13506" r="34415" b="14834"/>
            <a:stretch/>
          </p:blipFill>
          <p:spPr>
            <a:xfrm>
              <a:off x="4191120" y="4060440"/>
              <a:ext cx="1152360" cy="432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0" name="Picture 54" descr="G:\서영 삼성 랩탑\HRK1\northern\2weeks\ssk1.jpg"/>
            <p:cNvPicPr/>
            <p:nvPr/>
          </p:nvPicPr>
          <p:blipFill>
            <a:blip r:embed="rId18"/>
            <a:srcRect l="33333" t="0" r="33333" b="-6040"/>
            <a:stretch/>
          </p:blipFill>
          <p:spPr>
            <a:xfrm>
              <a:off x="4191120" y="3591000"/>
              <a:ext cx="1152360" cy="430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sp>
        <p:nvSpPr>
          <p:cNvPr id="91" name="TextBox 69"/>
          <p:cNvSpPr/>
          <p:nvPr/>
        </p:nvSpPr>
        <p:spPr>
          <a:xfrm>
            <a:off x="1133640" y="1752480"/>
            <a:ext cx="428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70"/>
          <p:cNvSpPr/>
          <p:nvPr/>
        </p:nvSpPr>
        <p:spPr>
          <a:xfrm>
            <a:off x="1128600" y="3102120"/>
            <a:ext cx="4287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71"/>
          <p:cNvSpPr/>
          <p:nvPr/>
        </p:nvSpPr>
        <p:spPr>
          <a:xfrm>
            <a:off x="1128600" y="4467240"/>
            <a:ext cx="4287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직선 연결선 44"/>
          <p:cNvSpPr/>
          <p:nvPr/>
        </p:nvSpPr>
        <p:spPr>
          <a:xfrm flipH="1" flipV="1">
            <a:off x="2991960" y="2030400"/>
            <a:ext cx="10796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직선 연결선 44"/>
          <p:cNvSpPr/>
          <p:nvPr/>
        </p:nvSpPr>
        <p:spPr>
          <a:xfrm flipH="1" flipV="1">
            <a:off x="4214880" y="2030400"/>
            <a:ext cx="10792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그룹 2"/>
          <p:cNvGrpSpPr/>
          <p:nvPr/>
        </p:nvGrpSpPr>
        <p:grpSpPr>
          <a:xfrm>
            <a:off x="1643040" y="3143160"/>
            <a:ext cx="4349880" cy="1258920"/>
            <a:chOff x="1643040" y="3143160"/>
            <a:chExt cx="4349880" cy="1258920"/>
          </a:xfrm>
        </p:grpSpPr>
        <p:grpSp>
          <p:nvGrpSpPr>
            <p:cNvPr id="97" name="그룹 95"/>
            <p:cNvGrpSpPr/>
            <p:nvPr/>
          </p:nvGrpSpPr>
          <p:grpSpPr>
            <a:xfrm>
              <a:off x="1643040" y="3143160"/>
              <a:ext cx="4349880" cy="1258920"/>
              <a:chOff x="1643040" y="3143160"/>
              <a:chExt cx="4349880" cy="1258920"/>
            </a:xfrm>
          </p:grpSpPr>
          <p:sp>
            <p:nvSpPr>
              <p:cNvPr id="98" name="직선 연결선 44"/>
              <p:cNvSpPr/>
              <p:nvPr/>
            </p:nvSpPr>
            <p:spPr>
              <a:xfrm flipH="1" flipV="1">
                <a:off x="1744560" y="3382920"/>
                <a:ext cx="107928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1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TextBox 45"/>
              <p:cNvSpPr/>
              <p:nvPr/>
            </p:nvSpPr>
            <p:spPr>
              <a:xfrm>
                <a:off x="1643040" y="3143160"/>
                <a:ext cx="1347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WT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TextBox 75"/>
              <p:cNvSpPr/>
              <p:nvPr/>
            </p:nvSpPr>
            <p:spPr>
              <a:xfrm>
                <a:off x="1803240" y="3353400"/>
                <a:ext cx="104292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     30    60   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TextBox 76"/>
              <p:cNvSpPr/>
              <p:nvPr/>
            </p:nvSpPr>
            <p:spPr>
              <a:xfrm>
                <a:off x="3053160" y="3353400"/>
                <a:ext cx="1119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     30    60   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TextBox 77"/>
              <p:cNvSpPr/>
              <p:nvPr/>
            </p:nvSpPr>
            <p:spPr>
              <a:xfrm>
                <a:off x="4324320" y="3353400"/>
                <a:ext cx="1492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     30    60   min   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TextBox 87"/>
              <p:cNvSpPr/>
              <p:nvPr/>
            </p:nvSpPr>
            <p:spPr>
              <a:xfrm>
                <a:off x="5305680" y="3733560"/>
                <a:ext cx="685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RK1</a:t>
                </a:r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TextBox 88"/>
              <p:cNvSpPr/>
              <p:nvPr/>
            </p:nvSpPr>
            <p:spPr>
              <a:xfrm>
                <a:off x="5307120" y="4155840"/>
                <a:ext cx="685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RNA</a:t>
                </a:r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TextBox 45"/>
              <p:cNvSpPr/>
              <p:nvPr/>
            </p:nvSpPr>
            <p:spPr>
              <a:xfrm>
                <a:off x="3031920" y="3147840"/>
                <a:ext cx="99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hog1</a:t>
                </a:r>
                <a:r>
                  <a:rPr b="0" i="1" lang="el-GR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Δ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Box 45"/>
              <p:cNvSpPr/>
              <p:nvPr/>
            </p:nvSpPr>
            <p:spPr>
              <a:xfrm>
                <a:off x="4307400" y="3147840"/>
                <a:ext cx="99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ssk1</a:t>
                </a:r>
                <a:r>
                  <a:rPr b="0" i="1" lang="el-GR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Δ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7" name="직선 연결선 44"/>
            <p:cNvSpPr/>
            <p:nvPr/>
          </p:nvSpPr>
          <p:spPr>
            <a:xfrm flipH="1" flipV="1">
              <a:off x="3000240" y="3396960"/>
              <a:ext cx="1079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직선 연결선 44"/>
            <p:cNvSpPr/>
            <p:nvPr/>
          </p:nvSpPr>
          <p:spPr>
            <a:xfrm flipH="1" flipV="1">
              <a:off x="4222440" y="3396960"/>
              <a:ext cx="10810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9" name="그룹 1"/>
          <p:cNvGrpSpPr/>
          <p:nvPr/>
        </p:nvGrpSpPr>
        <p:grpSpPr>
          <a:xfrm>
            <a:off x="1643040" y="4564080"/>
            <a:ext cx="4349880" cy="1258920"/>
            <a:chOff x="1643040" y="4564080"/>
            <a:chExt cx="4349880" cy="1258920"/>
          </a:xfrm>
        </p:grpSpPr>
        <p:grpSp>
          <p:nvGrpSpPr>
            <p:cNvPr id="110" name="그룹 95"/>
            <p:cNvGrpSpPr/>
            <p:nvPr/>
          </p:nvGrpSpPr>
          <p:grpSpPr>
            <a:xfrm>
              <a:off x="1643040" y="4564080"/>
              <a:ext cx="4349880" cy="1258920"/>
              <a:chOff x="1643040" y="4564080"/>
              <a:chExt cx="4349880" cy="1258920"/>
            </a:xfrm>
          </p:grpSpPr>
          <p:sp>
            <p:nvSpPr>
              <p:cNvPr id="111" name="직선 연결선 44"/>
              <p:cNvSpPr/>
              <p:nvPr/>
            </p:nvSpPr>
            <p:spPr>
              <a:xfrm flipH="1" flipV="1">
                <a:off x="1744560" y="4803840"/>
                <a:ext cx="107928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1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TextBox 45"/>
              <p:cNvSpPr/>
              <p:nvPr/>
            </p:nvSpPr>
            <p:spPr>
              <a:xfrm>
                <a:off x="1643040" y="4564080"/>
                <a:ext cx="1347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WT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TextBox 75"/>
              <p:cNvSpPr/>
              <p:nvPr/>
            </p:nvSpPr>
            <p:spPr>
              <a:xfrm>
                <a:off x="1762920" y="4774320"/>
                <a:ext cx="104292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     30    60   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TextBox 76"/>
              <p:cNvSpPr/>
              <p:nvPr/>
            </p:nvSpPr>
            <p:spPr>
              <a:xfrm>
                <a:off x="3053160" y="4774320"/>
                <a:ext cx="1119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     30    60   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TextBox 77"/>
              <p:cNvSpPr/>
              <p:nvPr/>
            </p:nvSpPr>
            <p:spPr>
              <a:xfrm>
                <a:off x="4324320" y="4774320"/>
                <a:ext cx="1492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     30    60   min   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TextBox 87"/>
              <p:cNvSpPr/>
              <p:nvPr/>
            </p:nvSpPr>
            <p:spPr>
              <a:xfrm>
                <a:off x="5305680" y="5154480"/>
                <a:ext cx="685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RK1</a:t>
                </a:r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TextBox 88"/>
              <p:cNvSpPr/>
              <p:nvPr/>
            </p:nvSpPr>
            <p:spPr>
              <a:xfrm>
                <a:off x="5307120" y="5576760"/>
                <a:ext cx="685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RNA</a:t>
                </a:r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TextBox 45"/>
              <p:cNvSpPr/>
              <p:nvPr/>
            </p:nvSpPr>
            <p:spPr>
              <a:xfrm>
                <a:off x="3031920" y="4568760"/>
                <a:ext cx="99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hog1</a:t>
                </a:r>
                <a:r>
                  <a:rPr b="0" i="1" lang="el-GR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Δ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TextBox 45"/>
              <p:cNvSpPr/>
              <p:nvPr/>
            </p:nvSpPr>
            <p:spPr>
              <a:xfrm>
                <a:off x="4307400" y="4568760"/>
                <a:ext cx="99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ssk1</a:t>
                </a:r>
                <a:r>
                  <a:rPr b="0" i="1" lang="el-GR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Δ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0" name="직선 연결선 44"/>
            <p:cNvSpPr/>
            <p:nvPr/>
          </p:nvSpPr>
          <p:spPr>
            <a:xfrm flipH="1" flipV="1">
              <a:off x="3000240" y="4817880"/>
              <a:ext cx="1079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직선 연결선 44"/>
            <p:cNvSpPr/>
            <p:nvPr/>
          </p:nvSpPr>
          <p:spPr>
            <a:xfrm flipH="1" flipV="1">
              <a:off x="4222440" y="4817880"/>
              <a:ext cx="10810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2" name="Text Box 49"/>
          <p:cNvSpPr/>
          <p:nvPr/>
        </p:nvSpPr>
        <p:spPr>
          <a:xfrm rot="21597600">
            <a:off x="4948200" y="49320"/>
            <a:ext cx="165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굴림"/>
              </a:rPr>
              <a:t>Figure S1 (Kim et al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06T09:07:26Z</dcterms:created>
  <dc:creator>Yong-Sun/Bahn SUN</dc:creator>
  <dc:description/>
  <dc:language>en-US</dc:language>
  <cp:lastModifiedBy>Yong-Sun Bahn</cp:lastModifiedBy>
  <cp:lastPrinted>2011-01-13T08:16:49Z</cp:lastPrinted>
  <dcterms:modified xsi:type="dcterms:W3CDTF">2011-03-17T05:06:57Z</dcterms:modified>
  <cp:revision>57</cp:revision>
  <dc:subject/>
  <dc:title>PowerPoint Presentation</dc:title>
</cp:coreProperties>
</file>